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9/07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7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7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7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9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445224"/>
            <a:ext cx="7056784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isra (2025) Diabetologia DOI 10.1007/s00125-025-06513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51520" y="188640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Schematic diagram illustrating how ethnicity can impact type 2 diabetes risk and outcomes across the life course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C4A57C7-7416-6086-3E70-DD51A55476F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62696" y="1068038"/>
            <a:ext cx="6218609" cy="46652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5751926"/>
            <a:ext cx="712879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isra (2025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5-06513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520" y="188640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chematic diagram illustrating common sub-phenotypes of type 2 diabetes and which ethnic groups they predominate in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CBEFEAA-08F6-5A66-840C-2F7356DA369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09026" y="1078055"/>
            <a:ext cx="5725949" cy="4655201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5710469"/>
            <a:ext cx="70174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isra (2025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5-06513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23528" y="188640"/>
            <a:ext cx="82089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onceptual models for how ethnicity could be incorporated into precision medicine tools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57A2E96-1C9D-2EF4-2D7B-63667981D9B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8038" y="980728"/>
            <a:ext cx="7427924" cy="48245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0</Words>
  <Application>Microsoft Office PowerPoint</Application>
  <PresentationFormat>On-screen Show (4:3)</PresentationFormat>
  <Paragraphs>14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9</cp:revision>
  <dcterms:created xsi:type="dcterms:W3CDTF">2016-06-15T12:53:43Z</dcterms:created>
  <dcterms:modified xsi:type="dcterms:W3CDTF">2025-07-29T08:54:49Z</dcterms:modified>
</cp:coreProperties>
</file>